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CA034-C814-44A6-8F13-D98BBE2221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75FAB-64D3-4F63-BC09-299115645D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7FB4D-FBDC-4603-A008-6CB623AA3E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10FB3B-D28C-4ACF-8BCC-C90CCBFA43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831EC-AB8D-4084-84D4-6721398903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13B87-AF16-40F1-8A4C-26D657E812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87651-28BF-4E69-8C88-1573033C91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BF3F5D-B56A-41F9-A160-0FA875CAF7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0B9BCB-8D30-48D3-8201-9851C91673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EE4F35-726B-4389-AAEF-3C372127C0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D9B0F-EB77-4D2A-91FE-B90739EE05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A8B194-5027-47CC-AC68-4E7D9A3F0C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17A369-059E-4A2A-9247-539B8D4FA79B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2"/>
          <p:cNvSpPr/>
          <p:nvPr/>
        </p:nvSpPr>
        <p:spPr>
          <a:xfrm>
            <a:off x="395280" y="4869000"/>
            <a:ext cx="8613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Palatino Linotype"/>
              </a:rPr>
              <a:t>Figure S1. 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The protein domain of Rv0341 (A) and the structure of the surrounding genes of Rv0341 (B) . PHA03379 means  “EBNA-3A; Provisional”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539640" y="404640"/>
            <a:ext cx="7920000" cy="4248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1" descr=""/>
          <p:cNvPicPr/>
          <p:nvPr/>
        </p:nvPicPr>
        <p:blipFill>
          <a:blip r:embed="rId1"/>
          <a:stretch/>
        </p:blipFill>
        <p:spPr>
          <a:xfrm>
            <a:off x="2266920" y="1628640"/>
            <a:ext cx="4248360" cy="1652760"/>
          </a:xfrm>
          <a:prstGeom prst="rect">
            <a:avLst/>
          </a:prstGeom>
          <a:ln w="0">
            <a:noFill/>
          </a:ln>
        </p:spPr>
      </p:pic>
      <p:sp>
        <p:nvSpPr>
          <p:cNvPr id="44" name="TextBox 4"/>
          <p:cNvSpPr/>
          <p:nvPr/>
        </p:nvSpPr>
        <p:spPr>
          <a:xfrm>
            <a:off x="2266920" y="3500280"/>
            <a:ext cx="590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Figure </a:t>
            </a:r>
            <a:r>
              <a:rPr b="1" lang="en-US" sz="1000" spc="-1" strike="noStrike">
                <a:solidFill>
                  <a:srgbClr val="000000"/>
                </a:solidFill>
                <a:latin typeface="Palatino Linotype"/>
              </a:rPr>
              <a:t>S2</a:t>
            </a:r>
            <a:r>
              <a:rPr b="1" lang="en-US" sz="10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. 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Rv0341</a:t>
            </a:r>
            <a:r>
              <a:rPr b="1" lang="en-US" sz="1000" spc="-1" strike="noStrike">
                <a:solidFill>
                  <a:srgbClr val="000000"/>
                </a:solidFill>
                <a:latin typeface="Palatino Linotype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Palatino Linotype"/>
              </a:rPr>
              <a:t>expressed in the cell wall of </a:t>
            </a:r>
            <a:r>
              <a:rPr b="0" i="1" lang="en-US" sz="1000" spc="-1" strike="noStrike">
                <a:solidFill>
                  <a:srgbClr val="000000"/>
                </a:solidFill>
                <a:latin typeface="Palatino Linotype"/>
              </a:rPr>
              <a:t>M. smegmat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5-06T00:00:18Z</dcterms:created>
  <dc:creator>xielo</dc:creator>
  <dc:description/>
  <dc:language>en-US</dc:language>
  <cp:lastModifiedBy>FiVe-StAr</cp:lastModifiedBy>
  <dcterms:modified xsi:type="dcterms:W3CDTF">2020-06-05T10:13:31Z</dcterms:modified>
  <cp:revision>3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584</vt:lpwstr>
  </property>
</Properties>
</file>